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sec, Jan" initials="LJ" lastIdx="3" clrIdx="0">
    <p:extLst>
      <p:ext uri="{19B8F6BF-5375-455C-9EA6-DF929625EA0E}">
        <p15:presenceInfo xmlns="" xmlns:p15="http://schemas.microsoft.com/office/powerpoint/2012/main" userId="S-1-5-21-126249482-453980865-1851928258-304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FF3399"/>
    <a:srgbClr val="D60093"/>
    <a:srgbClr val="FF0066"/>
    <a:srgbClr val="FFFF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6324" autoAdjust="0"/>
    <p:restoredTop sz="84919" autoAdjust="0"/>
  </p:normalViewPr>
  <p:slideViewPr>
    <p:cSldViewPr>
      <p:cViewPr>
        <p:scale>
          <a:sx n="112" d="100"/>
          <a:sy n="112" d="100"/>
        </p:scale>
        <p:origin x="-960" y="19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3.6107491704402431E-2"/>
          <c:y val="2.7923211169284486E-2"/>
          <c:w val="0.94672512438749701"/>
          <c:h val="0.76711464731830026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2">
                <a:lumMod val="50000"/>
              </a:schemeClr>
            </a:solidFill>
            <a:ln>
              <a:noFill/>
            </a:ln>
            <a:effectLst>
              <a:innerShdw blurRad="114300">
                <a:schemeClr val="accent1"/>
              </a:innerShdw>
            </a:effectLst>
          </c:spPr>
          <c:dPt>
            <c:idx val="5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</c:dPt>
          <c:dPt>
            <c:idx val="6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6B8F-41C3-9A8B-4FEF1E8432BC}"/>
              </c:ext>
            </c:extLst>
          </c:dPt>
          <c:dPt>
            <c:idx val="7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6B8F-41C3-9A8B-4FEF1E8432BC}"/>
              </c:ext>
            </c:extLst>
          </c:dPt>
          <c:dPt>
            <c:idx val="8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6-6B8F-41C3-9A8B-4FEF1E8432BC}"/>
              </c:ext>
            </c:extLst>
          </c:dPt>
          <c:dPt>
            <c:idx val="9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E-6B8F-41C3-9A8B-4FEF1E8432BC}"/>
              </c:ext>
            </c:extLst>
          </c:dPt>
          <c:dPt>
            <c:idx val="10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</c:dPt>
          <c:dPt>
            <c:idx val="11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B8F-41C3-9A8B-4FEF1E8432BC}"/>
              </c:ext>
            </c:extLst>
          </c:dPt>
          <c:dPt>
            <c:idx val="12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C-6B8F-41C3-9A8B-4FEF1E8432BC}"/>
              </c:ext>
            </c:extLst>
          </c:dPt>
          <c:dPt>
            <c:idx val="13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6B8F-41C3-9A8B-4FEF1E8432BC}"/>
              </c:ext>
            </c:extLst>
          </c:dPt>
          <c:dPt>
            <c:idx val="14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F-6B8F-41C3-9A8B-4FEF1E8432BC}"/>
              </c:ext>
            </c:extLst>
          </c:dPt>
          <c:dPt>
            <c:idx val="15"/>
            <c:spPr>
              <a:solidFill>
                <a:schemeClr val="accent3">
                  <a:lumMod val="5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</c:dPt>
          <c:dPt>
            <c:idx val="16"/>
            <c:spPr>
              <a:solidFill>
                <a:schemeClr val="accent3">
                  <a:lumMod val="5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6B8F-41C3-9A8B-4FEF1E8432BC}"/>
              </c:ext>
            </c:extLst>
          </c:dPt>
          <c:dPt>
            <c:idx val="17"/>
            <c:spPr>
              <a:solidFill>
                <a:schemeClr val="accent3">
                  <a:lumMod val="5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6B8F-41C3-9A8B-4FEF1E8432BC}"/>
              </c:ext>
            </c:extLst>
          </c:dPt>
          <c:dPt>
            <c:idx val="18"/>
            <c:spPr>
              <a:solidFill>
                <a:schemeClr val="accent3">
                  <a:lumMod val="5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8-6B8F-41C3-9A8B-4FEF1E8432BC}"/>
              </c:ext>
            </c:extLst>
          </c:dPt>
          <c:dPt>
            <c:idx val="19"/>
            <c:spPr>
              <a:solidFill>
                <a:srgbClr val="00FFFF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</c:dPt>
          <c:dPt>
            <c:idx val="20"/>
            <c:spPr>
              <a:solidFill>
                <a:srgbClr val="00FFFF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6B8F-41C3-9A8B-4FEF1E8432BC}"/>
              </c:ext>
            </c:extLst>
          </c:dPt>
          <c:dPt>
            <c:idx val="21"/>
            <c:spPr>
              <a:solidFill>
                <a:srgbClr val="00FFFF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E-6B8F-41C3-9A8B-4FEF1E8432BC}"/>
              </c:ext>
            </c:extLst>
          </c:dPt>
          <c:dPt>
            <c:idx val="22"/>
            <c:spPr>
              <a:solidFill>
                <a:srgbClr val="00FFFF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9-6B8F-41C3-9A8B-4FEF1E8432BC}"/>
              </c:ext>
            </c:extLst>
          </c:dPt>
          <c:dPt>
            <c:idx val="23"/>
            <c:spPr>
              <a:solidFill>
                <a:srgbClr val="FFC000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</c:dPt>
          <c:dPt>
            <c:idx val="24"/>
            <c:spPr>
              <a:solidFill>
                <a:srgbClr val="FFC000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6-6B8F-41C3-9A8B-4FEF1E8432BC}"/>
              </c:ext>
            </c:extLst>
          </c:dPt>
          <c:dPt>
            <c:idx val="25"/>
            <c:spPr>
              <a:solidFill>
                <a:srgbClr val="FFC000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6B8F-41C3-9A8B-4FEF1E8432BC}"/>
              </c:ext>
            </c:extLst>
          </c:dPt>
          <c:dPt>
            <c:idx val="26"/>
            <c:spPr>
              <a:solidFill>
                <a:srgbClr val="FFC000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A-6B8F-41C3-9A8B-4FEF1E8432BC}"/>
              </c:ext>
            </c:extLst>
          </c:dPt>
          <c:dPt>
            <c:idx val="27"/>
            <c:spPr>
              <a:solidFill>
                <a:srgbClr val="FFC000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0-6B8F-41C3-9A8B-4FEF1E8432BC}"/>
              </c:ext>
            </c:extLst>
          </c:dPt>
          <c:errBars>
            <c:errBarType val="both"/>
            <c:errValType val="cust"/>
            <c:plus>
              <c:numRef>
                <c:f>'TG_Over All '!$B$66:$AC$66</c:f>
                <c:numCache>
                  <c:formatCode>General</c:formatCode>
                  <c:ptCount val="28"/>
                  <c:pt idx="0">
                    <c:v>0.12254219000646152</c:v>
                  </c:pt>
                  <c:pt idx="1">
                    <c:v>5.4601159382557052E-2</c:v>
                  </c:pt>
                  <c:pt idx="2">
                    <c:v>6.1967819619188159E-2</c:v>
                  </c:pt>
                  <c:pt idx="3">
                    <c:v>0.17365779456899524</c:v>
                  </c:pt>
                  <c:pt idx="4">
                    <c:v>3.939260321149754E-2</c:v>
                  </c:pt>
                  <c:pt idx="5">
                    <c:v>4.2583067554869014E-2</c:v>
                  </c:pt>
                  <c:pt idx="6">
                    <c:v>2.1726898542396001E-2</c:v>
                  </c:pt>
                  <c:pt idx="7">
                    <c:v>2.4633450624421158E-2</c:v>
                  </c:pt>
                  <c:pt idx="8">
                    <c:v>0.19696096240063707</c:v>
                  </c:pt>
                  <c:pt idx="9">
                    <c:v>0.20105046502425458</c:v>
                  </c:pt>
                  <c:pt idx="10">
                    <c:v>0.15054442945308449</c:v>
                  </c:pt>
                  <c:pt idx="11">
                    <c:v>0.10344489217046557</c:v>
                  </c:pt>
                  <c:pt idx="12">
                    <c:v>3.8640660806860141E-2</c:v>
                  </c:pt>
                  <c:pt idx="13">
                    <c:v>0.13215718871525878</c:v>
                  </c:pt>
                  <c:pt idx="14">
                    <c:v>4.0400953879632287E-2</c:v>
                  </c:pt>
                  <c:pt idx="15">
                    <c:v>0.11329966251975426</c:v>
                  </c:pt>
                  <c:pt idx="16">
                    <c:v>2.1892975129950192E-2</c:v>
                  </c:pt>
                  <c:pt idx="17">
                    <c:v>0.37893613995449094</c:v>
                  </c:pt>
                  <c:pt idx="18">
                    <c:v>2.1712821508162661E-2</c:v>
                  </c:pt>
                  <c:pt idx="19">
                    <c:v>0.11509127552862518</c:v>
                  </c:pt>
                  <c:pt idx="20">
                    <c:v>7.5588873999884332E-3</c:v>
                  </c:pt>
                  <c:pt idx="21">
                    <c:v>0.29558976914754787</c:v>
                  </c:pt>
                  <c:pt idx="22">
                    <c:v>0.15672318273483302</c:v>
                  </c:pt>
                  <c:pt idx="23">
                    <c:v>0.26690422270468184</c:v>
                  </c:pt>
                  <c:pt idx="24">
                    <c:v>1.4635748927018469E-2</c:v>
                  </c:pt>
                  <c:pt idx="25">
                    <c:v>6.5659284655985931E-2</c:v>
                  </c:pt>
                  <c:pt idx="26">
                    <c:v>0.27539007915575936</c:v>
                  </c:pt>
                  <c:pt idx="27">
                    <c:v>6.2159147454710448E-2</c:v>
                  </c:pt>
                </c:numCache>
              </c:numRef>
            </c:plus>
            <c:minus>
              <c:numRef>
                <c:f>'TG_Over All '!$B$66:$AC$66</c:f>
                <c:numCache>
                  <c:formatCode>General</c:formatCode>
                  <c:ptCount val="28"/>
                  <c:pt idx="0">
                    <c:v>0.12254219000646152</c:v>
                  </c:pt>
                  <c:pt idx="1">
                    <c:v>5.4601159382557052E-2</c:v>
                  </c:pt>
                  <c:pt idx="2">
                    <c:v>6.1967819619188159E-2</c:v>
                  </c:pt>
                  <c:pt idx="3">
                    <c:v>0.17365779456899524</c:v>
                  </c:pt>
                  <c:pt idx="4">
                    <c:v>3.939260321149754E-2</c:v>
                  </c:pt>
                  <c:pt idx="5">
                    <c:v>4.2583067554869014E-2</c:v>
                  </c:pt>
                  <c:pt idx="6">
                    <c:v>2.1726898542396001E-2</c:v>
                  </c:pt>
                  <c:pt idx="7">
                    <c:v>2.4633450624421158E-2</c:v>
                  </c:pt>
                  <c:pt idx="8">
                    <c:v>0.19696096240063707</c:v>
                  </c:pt>
                  <c:pt idx="9">
                    <c:v>0.20105046502425458</c:v>
                  </c:pt>
                  <c:pt idx="10">
                    <c:v>0.15054442945308449</c:v>
                  </c:pt>
                  <c:pt idx="11">
                    <c:v>0.10344489217046557</c:v>
                  </c:pt>
                  <c:pt idx="12">
                    <c:v>3.8640660806860141E-2</c:v>
                  </c:pt>
                  <c:pt idx="13">
                    <c:v>0.13215718871525878</c:v>
                  </c:pt>
                  <c:pt idx="14">
                    <c:v>4.0400953879632287E-2</c:v>
                  </c:pt>
                  <c:pt idx="15">
                    <c:v>0.11329966251975426</c:v>
                  </c:pt>
                  <c:pt idx="16">
                    <c:v>2.1892975129950192E-2</c:v>
                  </c:pt>
                  <c:pt idx="17">
                    <c:v>0.37893613995449094</c:v>
                  </c:pt>
                  <c:pt idx="18">
                    <c:v>2.1712821508162661E-2</c:v>
                  </c:pt>
                  <c:pt idx="19">
                    <c:v>0.11509127552862518</c:v>
                  </c:pt>
                  <c:pt idx="20">
                    <c:v>7.5588873999884332E-3</c:v>
                  </c:pt>
                  <c:pt idx="21">
                    <c:v>0.29558976914754787</c:v>
                  </c:pt>
                  <c:pt idx="22">
                    <c:v>0.15672318273483302</c:v>
                  </c:pt>
                  <c:pt idx="23">
                    <c:v>0.26690422270468184</c:v>
                  </c:pt>
                  <c:pt idx="24">
                    <c:v>1.4635748927018469E-2</c:v>
                  </c:pt>
                  <c:pt idx="25">
                    <c:v>6.5659284655985931E-2</c:v>
                  </c:pt>
                  <c:pt idx="26">
                    <c:v>0.27539007915575936</c:v>
                  </c:pt>
                  <c:pt idx="27">
                    <c:v>6.2159147454710448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multiLvlStrRef>
              <c:f>'TG_Over All '!$B$63:$AC$64</c:f>
              <c:multiLvlStrCache>
                <c:ptCount val="28"/>
                <c:lvl>
                  <c:pt idx="0">
                    <c:v>Nor</c:v>
                  </c:pt>
                  <c:pt idx="1">
                    <c:v>LPDS</c:v>
                  </c:pt>
                  <c:pt idx="2">
                    <c:v>LS</c:v>
                  </c:pt>
                  <c:pt idx="3">
                    <c:v>Hyp</c:v>
                  </c:pt>
                  <c:pt idx="4">
                    <c:v>Hyp+LS</c:v>
                  </c:pt>
                  <c:pt idx="5">
                    <c:v>Nor</c:v>
                  </c:pt>
                  <c:pt idx="6">
                    <c:v>LPDS</c:v>
                  </c:pt>
                  <c:pt idx="7">
                    <c:v>LS</c:v>
                  </c:pt>
                  <c:pt idx="8">
                    <c:v>Hyp</c:v>
                  </c:pt>
                  <c:pt idx="9">
                    <c:v>Hyp+LS</c:v>
                  </c:pt>
                  <c:pt idx="10">
                    <c:v>Nor</c:v>
                  </c:pt>
                  <c:pt idx="11">
                    <c:v>LPDS</c:v>
                  </c:pt>
                  <c:pt idx="12">
                    <c:v>LS</c:v>
                  </c:pt>
                  <c:pt idx="13">
                    <c:v>Hyp</c:v>
                  </c:pt>
                  <c:pt idx="14">
                    <c:v>Hyp+LS</c:v>
                  </c:pt>
                  <c:pt idx="15">
                    <c:v>N</c:v>
                  </c:pt>
                  <c:pt idx="16">
                    <c:v>LPDS</c:v>
                  </c:pt>
                  <c:pt idx="17">
                    <c:v>LS</c:v>
                  </c:pt>
                  <c:pt idx="18">
                    <c:v>Hyp</c:v>
                  </c:pt>
                  <c:pt idx="19">
                    <c:v>N</c:v>
                  </c:pt>
                  <c:pt idx="20">
                    <c:v>LPDS</c:v>
                  </c:pt>
                  <c:pt idx="21">
                    <c:v>LS</c:v>
                  </c:pt>
                  <c:pt idx="22">
                    <c:v>Hyp</c:v>
                  </c:pt>
                  <c:pt idx="23">
                    <c:v>N</c:v>
                  </c:pt>
                  <c:pt idx="24">
                    <c:v>LPDS</c:v>
                  </c:pt>
                  <c:pt idx="25">
                    <c:v>LS</c:v>
                  </c:pt>
                  <c:pt idx="26">
                    <c:v>Hyp</c:v>
                  </c:pt>
                  <c:pt idx="27">
                    <c:v>Hyp+LS</c:v>
                  </c:pt>
                </c:lvl>
                <c:lvl>
                  <c:pt idx="0">
                    <c:v>KCl22</c:v>
                  </c:pt>
                  <c:pt idx="5">
                    <c:v>KG1</c:v>
                  </c:pt>
                  <c:pt idx="10">
                    <c:v>KU812</c:v>
                  </c:pt>
                  <c:pt idx="15">
                    <c:v>SW480</c:v>
                  </c:pt>
                  <c:pt idx="19">
                    <c:v>SW620</c:v>
                  </c:pt>
                  <c:pt idx="23">
                    <c:v>A549</c:v>
                  </c:pt>
                </c:lvl>
              </c:multiLvlStrCache>
            </c:multiLvlStrRef>
          </c:cat>
          <c:val>
            <c:numRef>
              <c:f>'TG_Over All '!$B$65:$AC$65</c:f>
              <c:numCache>
                <c:formatCode>General</c:formatCode>
                <c:ptCount val="28"/>
                <c:pt idx="0">
                  <c:v>1</c:v>
                </c:pt>
                <c:pt idx="1">
                  <c:v>0.58834502050030912</c:v>
                </c:pt>
                <c:pt idx="2">
                  <c:v>0.16726613658025366</c:v>
                </c:pt>
                <c:pt idx="3">
                  <c:v>1.2923726183552555</c:v>
                </c:pt>
                <c:pt idx="4">
                  <c:v>0.18942651371594391</c:v>
                </c:pt>
                <c:pt idx="5">
                  <c:v>1</c:v>
                </c:pt>
                <c:pt idx="6">
                  <c:v>1.1939427904445119</c:v>
                </c:pt>
                <c:pt idx="7">
                  <c:v>0.44304630650816734</c:v>
                </c:pt>
                <c:pt idx="8">
                  <c:v>1.5717360204159074</c:v>
                </c:pt>
                <c:pt idx="9">
                  <c:v>0.58877351749214679</c:v>
                </c:pt>
                <c:pt idx="10">
                  <c:v>1</c:v>
                </c:pt>
                <c:pt idx="11">
                  <c:v>0.53512375413913604</c:v>
                </c:pt>
                <c:pt idx="12">
                  <c:v>0.25035783024024888</c:v>
                </c:pt>
                <c:pt idx="13">
                  <c:v>0.84265814311222498</c:v>
                </c:pt>
                <c:pt idx="14">
                  <c:v>0.23099536910922902</c:v>
                </c:pt>
                <c:pt idx="15">
                  <c:v>1</c:v>
                </c:pt>
                <c:pt idx="16">
                  <c:v>0.63298526092124452</c:v>
                </c:pt>
                <c:pt idx="17">
                  <c:v>0.60868670196281016</c:v>
                </c:pt>
                <c:pt idx="18">
                  <c:v>0.9122817010702492</c:v>
                </c:pt>
                <c:pt idx="19">
                  <c:v>1</c:v>
                </c:pt>
                <c:pt idx="20">
                  <c:v>0.30085237356752026</c:v>
                </c:pt>
                <c:pt idx="21">
                  <c:v>0.60590026536184205</c:v>
                </c:pt>
                <c:pt idx="22">
                  <c:v>0.71760613675118945</c:v>
                </c:pt>
                <c:pt idx="23">
                  <c:v>1</c:v>
                </c:pt>
                <c:pt idx="24">
                  <c:v>0.15068363382769909</c:v>
                </c:pt>
                <c:pt idx="25">
                  <c:v>0.37276161685577031</c:v>
                </c:pt>
                <c:pt idx="26">
                  <c:v>1.2073186683433659</c:v>
                </c:pt>
                <c:pt idx="27">
                  <c:v>0.429145119462159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B8F-41C3-9A8B-4FEF1E8432BC}"/>
            </c:ext>
          </c:extLst>
        </c:ser>
        <c:gapWidth val="164"/>
        <c:overlap val="-22"/>
        <c:axId val="91579904"/>
        <c:axId val="91581440"/>
      </c:barChart>
      <c:catAx>
        <c:axId val="9157990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1905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581440"/>
        <c:crosses val="autoZero"/>
        <c:auto val="1"/>
        <c:lblAlgn val="ctr"/>
        <c:lblOffset val="100"/>
      </c:catAx>
      <c:valAx>
        <c:axId val="91581440"/>
        <c:scaling>
          <c:orientation val="minMax"/>
        </c:scaling>
        <c:axPos val="l"/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579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 sz="1000"/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A15945-6199-4706-9261-44B47929DB86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94DFB6-8908-4C5C-81EA-23F4DA78596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20663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2: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ld-changes in triglyceride-content </a:t>
            </a:r>
            <a:r>
              <a:rPr lang="en-US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CL22 (Leukemia), KG1 (Leukemia), KU812 (Leukemia), SW480 (Colon cancer), SW620 (Colon cancer) and A549 (Lung Cancer)</a:t>
            </a:r>
            <a:r>
              <a:rPr lang="en-US" sz="1200" u="none" strike="noStrike" baseline="0" smtClean="0">
                <a:effectLst/>
              </a:rPr>
              <a:t> </a:t>
            </a:r>
            <a:r>
              <a:rPr lang="en-US" sz="1200" u="none" strike="noStrike" baseline="0" dirty="0" smtClean="0">
                <a:effectLst/>
              </a:rPr>
              <a:t>cell lines under Nor, LPDS, LS, </a:t>
            </a:r>
            <a:r>
              <a:rPr lang="en-US" sz="1200" u="none" strike="noStrike" baseline="0" dirty="0" err="1" smtClean="0">
                <a:effectLst/>
              </a:rPr>
              <a:t>Hyp</a:t>
            </a:r>
            <a:r>
              <a:rPr lang="en-US" sz="1200" u="none" strike="noStrike" baseline="0" dirty="0" smtClean="0">
                <a:effectLst/>
              </a:rPr>
              <a:t> or </a:t>
            </a:r>
            <a:r>
              <a:rPr lang="en-US" sz="1200" u="none" strike="noStrike" baseline="0" dirty="0" err="1" smtClean="0">
                <a:effectLst/>
              </a:rPr>
              <a:t>Hyp+LS</a:t>
            </a:r>
            <a:r>
              <a:rPr lang="en-US" sz="1200" u="none" strike="noStrike" baseline="0" dirty="0" smtClean="0">
                <a:effectLst/>
              </a:rPr>
              <a:t> conditions.</a:t>
            </a:r>
            <a:endParaRPr lang="en-US" b="1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94DFB6-8908-4C5C-81EA-23F4DA78596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976998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45721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41710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05683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56111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98847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6255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4732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61549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39769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0883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99800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2701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rot="16200000">
            <a:off x="-523106" y="3723506"/>
            <a:ext cx="1720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Total TG Content (Fold-Change) </a:t>
            </a:r>
          </a:p>
          <a:p>
            <a:endParaRPr lang="en-US" sz="900" b="1" dirty="0"/>
          </a:p>
        </p:txBody>
      </p:sp>
      <p:graphicFrame>
        <p:nvGraphicFramePr>
          <p:cNvPr id="10" name="Chart 9">
            <a:extLst>
              <a:ext uri="{FF2B5EF4-FFF2-40B4-BE49-F238E27FC236}">
                <a16:creationId xmlns:xdr="http://schemas.openxmlformats.org/drawingml/2006/spreadsheetDrawing" xmlns:a16="http://schemas.microsoft.com/office/drawing/2014/main" xmlns="" xmlns:lc="http://schemas.openxmlformats.org/drawingml/2006/lockedCanvas" id="{90D7E915-A699-4DF7-9FA6-B5A1CD94B0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032797333"/>
              </p:ext>
            </p:extLst>
          </p:nvPr>
        </p:nvGraphicFramePr>
        <p:xfrm>
          <a:off x="365640" y="2819400"/>
          <a:ext cx="6305549" cy="29051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="" xmlns:p14="http://schemas.microsoft.com/office/powerpoint/2010/main" val="2808070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1</TotalTime>
  <Words>57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Nousheen Zaidi</dc:creator>
  <cp:lastModifiedBy>Rida Rashid</cp:lastModifiedBy>
  <cp:revision>244</cp:revision>
  <dcterms:created xsi:type="dcterms:W3CDTF">2017-10-04T17:41:58Z</dcterms:created>
  <dcterms:modified xsi:type="dcterms:W3CDTF">2019-04-06T22:07:51Z</dcterms:modified>
</cp:coreProperties>
</file>